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73" userDrawn="1">
          <p15:clr>
            <a:srgbClr val="A4A3A4"/>
          </p15:clr>
        </p15:guide>
        <p15:guide id="2" pos="381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38EFF"/>
    <a:srgbClr val="7E87F5"/>
    <a:srgbClr val="00B0AF"/>
    <a:srgbClr val="EB24DA"/>
    <a:srgbClr val="0093F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878"/>
    <p:restoredTop sz="94626"/>
  </p:normalViewPr>
  <p:slideViewPr>
    <p:cSldViewPr snapToGrid="0" snapToObjects="1" showGuides="1">
      <p:cViewPr varScale="1">
        <p:scale>
          <a:sx n="121" d="100"/>
          <a:sy n="121" d="100"/>
        </p:scale>
        <p:origin x="1040" y="168"/>
      </p:cViewPr>
      <p:guideLst>
        <p:guide orient="horz" pos="2273"/>
        <p:guide pos="381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2576C2-81C3-D349-8DDB-AE13FA5CA8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F8D1FCEB-0AC2-E142-86BA-A7FB2F3B55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830B300-593D-AF40-A548-241D84A458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A962FE-6E87-9048-8A32-F40964514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50BC1F9-E3E8-C04B-80DD-3D7798504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34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F6B788-8238-4D4E-8BFF-DB3C223D7C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481272B-CAD7-4448-AF18-D49FD22D89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76D962-A239-4645-A9E0-6603902540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012CD7-CDE5-C84C-B805-915A6971AC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D472864-717C-764F-94E9-896B24161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0445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A4FA247-5D32-9C40-AB17-6641C4F0CA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53B6E20-8D30-4F43-AE6B-0FC4455F1C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F09C9C5-C1D2-4644-BAAB-F8DB606E29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7B6B84C-6866-C542-A5C5-A6F950F5F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C65DD0-8A22-284D-97A3-7C8F851C05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1948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277ECD-A799-0F40-AB24-6232BAE1F1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09F1CDD-7AF9-9042-A40D-33AA736D3D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05F9BD3-51E7-1D4B-B09D-DDCACA5A45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0DE492-5FAF-424A-9E08-66C8CEBEC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7387F0B-B51B-F74F-9BFE-ED1D7E3BC4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806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6C2581-2DB0-E542-A1DD-053868BCC6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39B500-828D-814A-9A8E-8D849CE0E6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C364A57-89A0-BD45-9AC8-491CED5C1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56F5FE-35B7-C84C-874E-7FF0EEAAC3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C9D1FCF-DD8F-EC4E-B3E2-3EFD0CEED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6789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8CBF6E-5833-A543-B489-3E3631AB2A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47AB57B-4F7F-2242-A28C-EDD1EB5081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45E3011-311B-7A41-BB60-61320A2B52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5DE65E7-5ACC-FC40-9012-8CF991C9B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280E664-A69C-D54F-B18E-47224606BD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B36CFBA-0934-D241-A946-8474509989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75271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DD8C9D9-9C09-B740-8047-6453D8D98A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EE8AA39-9EF3-344C-AD22-5F4AE5FFA7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F354467-1C94-8942-B5F1-CAE1DD4CBC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2975835-5748-C346-A3D8-F6F08C853B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1675998-C3F4-374F-984A-DA048BB67A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0B85433-1809-C448-9AE2-93BF632E3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BD5C783-FCA5-4942-B311-D50490AD84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9991C30-77B0-5743-BCA8-334B2B45A2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681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A1DC54-2DFA-B64B-A8D6-EF462D5B5C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60E58A1-119A-FB46-9C7B-60E3ED01C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0E394EE-BB41-8743-B32D-95BB3FB845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F22A1F0-63E5-6847-91CD-9DB0F1B95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34391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448614F-11ED-0A4A-9109-A853CD5D1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03F3F77-51FB-AE41-B511-35E0710AC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FC21DE1-661C-B347-8473-EC3AD71006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9116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C2F7CB8-F977-0D45-90B1-6FBE1017AC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920704D-64ED-7A49-9EC4-915F0A1B6D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9D627B-E5E2-534A-8987-8654881EA8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1135796-1823-E84B-95DF-25B47DB8B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8DAC8B1-94A3-D644-A22D-4432404AC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2DD26B2-9538-ED41-8D7A-3DE090380C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28335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C2D8B04-97E0-FF4F-A323-00A888E088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DE8CFFD-3986-084F-8AA4-CC949603632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B9E5DF6-CC83-DD4B-B198-6BC0FF66AC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537E59E-4A45-ED4B-BF09-CDE142129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1904EC4-1D79-2847-B2A6-CADA95779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AC64192-8E95-374B-9599-66429CFF0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1388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0DFAA59-CE71-A94B-A224-F063E2F4CE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116A8AC-DFD3-7648-864B-3E8AF92854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680554-F05F-A341-8BC8-64E31BB139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84CA77-2102-394F-89BF-257BD3A4DA5D}" type="datetimeFigureOut">
              <a:rPr kumimoji="1" lang="ja-JP" altLang="en-US" smtClean="0"/>
              <a:t>2026/1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9FA237-8AFE-504B-A1F2-BF412ED11D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7CF77B-7C78-2E4B-BF75-80FEB8122E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29D5E-5DDF-E146-AA94-7571BA5BF8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6943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コンテンツ プレースホルダー 7">
            <a:extLst>
              <a:ext uri="{FF2B5EF4-FFF2-40B4-BE49-F238E27FC236}">
                <a16:creationId xmlns:a16="http://schemas.microsoft.com/office/drawing/2014/main" id="{A30F9C1D-ACC3-044B-9ECC-22038550E3C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07" t="50716" r="10159" b="33671"/>
          <a:stretch/>
        </p:blipFill>
        <p:spPr>
          <a:xfrm>
            <a:off x="3289040" y="2767444"/>
            <a:ext cx="5880212" cy="677067"/>
          </a:xfrm>
          <a:prstGeom prst="rect">
            <a:avLst/>
          </a:prstGeom>
          <a:scene3d>
            <a:camera prst="orthographicFront">
              <a:rot lat="0" lon="0" rev="0"/>
            </a:camera>
            <a:lightRig rig="threePt" dir="t"/>
          </a:scene3d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BE6282D-CFDB-504B-B91D-7234717B8DE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65" t="50077" r="8455" b="38111"/>
          <a:stretch/>
        </p:blipFill>
        <p:spPr>
          <a:xfrm>
            <a:off x="3289037" y="2106080"/>
            <a:ext cx="5880215" cy="609428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C6BE1433-8D3F-6F42-9FD2-2043F54F710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5" t="54167" r="20019" b="31898"/>
          <a:stretch/>
        </p:blipFill>
        <p:spPr>
          <a:xfrm>
            <a:off x="3294407" y="5189280"/>
            <a:ext cx="5874845" cy="666930"/>
          </a:xfrm>
          <a:prstGeom prst="rect">
            <a:avLst/>
          </a:prstGeom>
          <a:scene3d>
            <a:camera prst="orthographicFront">
              <a:rot lat="0" lon="0" rev="0"/>
            </a:camera>
            <a:lightRig rig="threePt" dir="t"/>
          </a:scene3d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8CD7DB0D-9857-8443-8CF1-5FD3224EC0D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7" t="47375" r="21469" b="39500"/>
          <a:stretch/>
        </p:blipFill>
        <p:spPr>
          <a:xfrm>
            <a:off x="3294407" y="4429286"/>
            <a:ext cx="5874845" cy="653568"/>
          </a:xfrm>
          <a:prstGeom prst="rect">
            <a:avLst/>
          </a:prstGeom>
        </p:spPr>
      </p:pic>
      <p:sp>
        <p:nvSpPr>
          <p:cNvPr id="8" name="テキスト ボックス 62">
            <a:extLst>
              <a:ext uri="{FF2B5EF4-FFF2-40B4-BE49-F238E27FC236}">
                <a16:creationId xmlns:a16="http://schemas.microsoft.com/office/drawing/2014/main" id="{0BAEC0CF-112D-9E4B-BD58-A6828F15B600}"/>
              </a:ext>
            </a:extLst>
          </p:cNvPr>
          <p:cNvSpPr txBox="1"/>
          <p:nvPr/>
        </p:nvSpPr>
        <p:spPr>
          <a:xfrm rot="19200000">
            <a:off x="1651924" y="2075851"/>
            <a:ext cx="4229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63">
            <a:extLst>
              <a:ext uri="{FF2B5EF4-FFF2-40B4-BE49-F238E27FC236}">
                <a16:creationId xmlns:a16="http://schemas.microsoft.com/office/drawing/2014/main" id="{FA1F7C7C-E0D5-E544-8B36-A17EB024D3D5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7787152" y="3900948"/>
            <a:ext cx="96168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olon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64">
            <a:extLst>
              <a:ext uri="{FF2B5EF4-FFF2-40B4-BE49-F238E27FC236}">
                <a16:creationId xmlns:a16="http://schemas.microsoft.com/office/drawing/2014/main" id="{2B52F000-C934-504A-8B11-4952104C7C40}"/>
              </a:ext>
            </a:extLst>
          </p:cNvPr>
          <p:cNvSpPr txBox="1">
            <a:spLocks noChangeArrowheads="1"/>
          </p:cNvSpPr>
          <p:nvPr/>
        </p:nvSpPr>
        <p:spPr bwMode="auto">
          <a:xfrm rot="18774326">
            <a:off x="3406586" y="1109417"/>
            <a:ext cx="221265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erebrum cortex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65">
            <a:extLst>
              <a:ext uri="{FF2B5EF4-FFF2-40B4-BE49-F238E27FC236}">
                <a16:creationId xmlns:a16="http://schemas.microsoft.com/office/drawing/2014/main" id="{20A49E8A-7548-FA45-9593-DD8E7FCE248B}"/>
              </a:ext>
            </a:extLst>
          </p:cNvPr>
          <p:cNvSpPr txBox="1">
            <a:spLocks noChangeArrowheads="1"/>
          </p:cNvSpPr>
          <p:nvPr/>
        </p:nvSpPr>
        <p:spPr bwMode="auto">
          <a:xfrm rot="18706138">
            <a:off x="3908209" y="1377621"/>
            <a:ext cx="146104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  <a:r>
              <a:rPr kumimoji="0" lang="ja-JP" altLang="ja-JP" sz="140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endParaRPr kumimoji="0" lang="ja-JP" altLang="ja-JP" sz="140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66">
            <a:extLst>
              <a:ext uri="{FF2B5EF4-FFF2-40B4-BE49-F238E27FC236}">
                <a16:creationId xmlns:a16="http://schemas.microsoft.com/office/drawing/2014/main" id="{B9372F35-A716-944A-9EA7-0F7E0B1428E8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8514905" y="3902956"/>
            <a:ext cx="95636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skin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68">
            <a:extLst>
              <a:ext uri="{FF2B5EF4-FFF2-40B4-BE49-F238E27FC236}">
                <a16:creationId xmlns:a16="http://schemas.microsoft.com/office/drawing/2014/main" id="{83A9A9F5-7D14-134E-BAAF-1B36306AEBA9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6115913" y="3899658"/>
            <a:ext cx="96510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ja-JP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stis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35">
            <a:extLst>
              <a:ext uri="{FF2B5EF4-FFF2-40B4-BE49-F238E27FC236}">
                <a16:creationId xmlns:a16="http://schemas.microsoft.com/office/drawing/2014/main" id="{37A2AC38-5860-B242-B178-D8673B6AD8C2}"/>
              </a:ext>
            </a:extLst>
          </p:cNvPr>
          <p:cNvSpPr txBox="1">
            <a:spLocks noChangeArrowheads="1"/>
          </p:cNvSpPr>
          <p:nvPr/>
        </p:nvSpPr>
        <p:spPr bwMode="auto">
          <a:xfrm rot="18845187">
            <a:off x="5334629" y="1258626"/>
            <a:ext cx="183321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one</a:t>
            </a:r>
            <a:r>
              <a:rPr kumimoji="0" lang="ja-JP" altLang="ja-JP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arrow</a:t>
            </a:r>
            <a:r>
              <a:rPr kumimoji="0" lang="ja-JP" altLang="ja-JP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36">
            <a:extLst>
              <a:ext uri="{FF2B5EF4-FFF2-40B4-BE49-F238E27FC236}">
                <a16:creationId xmlns:a16="http://schemas.microsoft.com/office/drawing/2014/main" id="{33B502F8-C5A1-BD44-A856-477BAF961D8F}"/>
              </a:ext>
            </a:extLst>
          </p:cNvPr>
          <p:cNvSpPr txBox="1">
            <a:spLocks noChangeArrowheads="1"/>
          </p:cNvSpPr>
          <p:nvPr/>
        </p:nvSpPr>
        <p:spPr bwMode="auto">
          <a:xfrm rot="18897753">
            <a:off x="4992274" y="1398266"/>
            <a:ext cx="1501382" cy="352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pinal cord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39">
            <a:extLst>
              <a:ext uri="{FF2B5EF4-FFF2-40B4-BE49-F238E27FC236}">
                <a16:creationId xmlns:a16="http://schemas.microsoft.com/office/drawing/2014/main" id="{F16D5E2A-282C-B94F-A458-4495B5DC70D3}"/>
              </a:ext>
            </a:extLst>
          </p:cNvPr>
          <p:cNvSpPr txBox="1">
            <a:spLocks noChangeArrowheads="1"/>
          </p:cNvSpPr>
          <p:nvPr/>
        </p:nvSpPr>
        <p:spPr bwMode="auto">
          <a:xfrm rot="-2400000">
            <a:off x="5815783" y="1665051"/>
            <a:ext cx="74358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ye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40">
            <a:extLst>
              <a:ext uri="{FF2B5EF4-FFF2-40B4-BE49-F238E27FC236}">
                <a16:creationId xmlns:a16="http://schemas.microsoft.com/office/drawing/2014/main" id="{077BB99C-44E2-7444-B30B-AFB5F523526C}"/>
              </a:ext>
            </a:extLst>
          </p:cNvPr>
          <p:cNvSpPr txBox="1">
            <a:spLocks noChangeArrowheads="1"/>
          </p:cNvSpPr>
          <p:nvPr/>
        </p:nvSpPr>
        <p:spPr bwMode="auto">
          <a:xfrm rot="18728781">
            <a:off x="6151041" y="1500371"/>
            <a:ext cx="11362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ongue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42">
            <a:extLst>
              <a:ext uri="{FF2B5EF4-FFF2-40B4-BE49-F238E27FC236}">
                <a16:creationId xmlns:a16="http://schemas.microsoft.com/office/drawing/2014/main" id="{440DD60D-63D9-DD41-A595-1536D5236193}"/>
              </a:ext>
            </a:extLst>
          </p:cNvPr>
          <p:cNvSpPr txBox="1">
            <a:spLocks noChangeArrowheads="1"/>
          </p:cNvSpPr>
          <p:nvPr/>
        </p:nvSpPr>
        <p:spPr bwMode="auto">
          <a:xfrm rot="18834949">
            <a:off x="6433183" y="1331236"/>
            <a:ext cx="162745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sophagus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43">
            <a:extLst>
              <a:ext uri="{FF2B5EF4-FFF2-40B4-BE49-F238E27FC236}">
                <a16:creationId xmlns:a16="http://schemas.microsoft.com/office/drawing/2014/main" id="{F26B10AC-7AFB-3046-B1F8-A752EBCF23A8}"/>
              </a:ext>
            </a:extLst>
          </p:cNvPr>
          <p:cNvSpPr txBox="1">
            <a:spLocks noChangeArrowheads="1"/>
          </p:cNvSpPr>
          <p:nvPr/>
        </p:nvSpPr>
        <p:spPr bwMode="auto">
          <a:xfrm rot="18917260">
            <a:off x="6877813" y="1537876"/>
            <a:ext cx="106997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tomach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44">
            <a:extLst>
              <a:ext uri="{FF2B5EF4-FFF2-40B4-BE49-F238E27FC236}">
                <a16:creationId xmlns:a16="http://schemas.microsoft.com/office/drawing/2014/main" id="{40B0DBF9-5D10-FF49-ADD6-13C7B97A8A20}"/>
              </a:ext>
            </a:extLst>
          </p:cNvPr>
          <p:cNvSpPr txBox="1">
            <a:spLocks noChangeArrowheads="1"/>
          </p:cNvSpPr>
          <p:nvPr/>
        </p:nvSpPr>
        <p:spPr bwMode="auto">
          <a:xfrm rot="18871132">
            <a:off x="7177979" y="1582567"/>
            <a:ext cx="974725" cy="301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eart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45">
            <a:extLst>
              <a:ext uri="{FF2B5EF4-FFF2-40B4-BE49-F238E27FC236}">
                <a16:creationId xmlns:a16="http://schemas.microsoft.com/office/drawing/2014/main" id="{E94D65EA-8745-804D-8A5C-A1CC65031544}"/>
              </a:ext>
            </a:extLst>
          </p:cNvPr>
          <p:cNvSpPr txBox="1">
            <a:spLocks noChangeArrowheads="1"/>
          </p:cNvSpPr>
          <p:nvPr/>
        </p:nvSpPr>
        <p:spPr bwMode="auto">
          <a:xfrm rot="18617802">
            <a:off x="7544730" y="1527108"/>
            <a:ext cx="104616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lung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46">
            <a:extLst>
              <a:ext uri="{FF2B5EF4-FFF2-40B4-BE49-F238E27FC236}">
                <a16:creationId xmlns:a16="http://schemas.microsoft.com/office/drawing/2014/main" id="{58CE8444-0D16-194D-9E78-022066B078CA}"/>
              </a:ext>
            </a:extLst>
          </p:cNvPr>
          <p:cNvSpPr txBox="1">
            <a:spLocks noChangeArrowheads="1"/>
          </p:cNvSpPr>
          <p:nvPr/>
        </p:nvSpPr>
        <p:spPr bwMode="auto">
          <a:xfrm rot="18564123">
            <a:off x="8262583" y="1464850"/>
            <a:ext cx="119948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ymus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47">
            <a:extLst>
              <a:ext uri="{FF2B5EF4-FFF2-40B4-BE49-F238E27FC236}">
                <a16:creationId xmlns:a16="http://schemas.microsoft.com/office/drawing/2014/main" id="{14CFFAF7-DFF6-004E-B98E-D44B043AC453}"/>
              </a:ext>
            </a:extLst>
          </p:cNvPr>
          <p:cNvSpPr txBox="1">
            <a:spLocks noChangeArrowheads="1"/>
          </p:cNvSpPr>
          <p:nvPr/>
        </p:nvSpPr>
        <p:spPr bwMode="auto">
          <a:xfrm rot="18653432">
            <a:off x="7834788" y="1402745"/>
            <a:ext cx="13806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Yu Mincho Demibold" panose="02020400000000000000" pitchFamily="18" charset="-128"/>
                <a:cs typeface="Arial" panose="020B0604020202020204" pitchFamily="34" charset="0"/>
              </a:rPr>
              <a:t>diaphragm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ea typeface="Yu Mincho Demibold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24" name="テキスト ボックス 49">
            <a:extLst>
              <a:ext uri="{FF2B5EF4-FFF2-40B4-BE49-F238E27FC236}">
                <a16:creationId xmlns:a16="http://schemas.microsoft.com/office/drawing/2014/main" id="{1A86826E-F019-FE4C-A09F-644CFFD5433A}"/>
              </a:ext>
            </a:extLst>
          </p:cNvPr>
          <p:cNvSpPr txBox="1">
            <a:spLocks noChangeArrowheads="1"/>
          </p:cNvSpPr>
          <p:nvPr/>
        </p:nvSpPr>
        <p:spPr bwMode="auto">
          <a:xfrm rot="18830487">
            <a:off x="4025920" y="777687"/>
            <a:ext cx="2655251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br>
              <a:rPr lang="en-US" altLang="ja-JP" sz="1400" dirty="0"/>
            </a:b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ypothalamus</a:t>
            </a:r>
            <a:endParaRPr kumimoji="0" lang="ja-JP" altLang="ja-JP" sz="140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74">
            <a:extLst>
              <a:ext uri="{FF2B5EF4-FFF2-40B4-BE49-F238E27FC236}">
                <a16:creationId xmlns:a16="http://schemas.microsoft.com/office/drawing/2014/main" id="{4C48FE83-ABF6-E84F-9B81-B4D7F2E3D2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51232" y="4686595"/>
            <a:ext cx="104901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3</a:t>
            </a: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00bp</a:t>
            </a:r>
            <a:r>
              <a:rPr kumimoji="0" lang="en-US" altLang="ja-JP" sz="16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" name="テキスト ボックス 74">
            <a:extLst>
              <a:ext uri="{FF2B5EF4-FFF2-40B4-BE49-F238E27FC236}">
                <a16:creationId xmlns:a16="http://schemas.microsoft.com/office/drawing/2014/main" id="{2AEB993A-B67B-A74E-BD08-BEBCBA8AC9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8775" y="2206400"/>
            <a:ext cx="104901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3</a:t>
            </a: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00bp</a:t>
            </a:r>
            <a:r>
              <a:rPr kumimoji="0" lang="en-US" altLang="ja-JP" sz="16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" name="テキスト ボックス 74">
            <a:extLst>
              <a:ext uri="{FF2B5EF4-FFF2-40B4-BE49-F238E27FC236}">
                <a16:creationId xmlns:a16="http://schemas.microsoft.com/office/drawing/2014/main" id="{A0148AEF-16C9-EC4C-83C2-BA20194CA7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40345" y="5466069"/>
            <a:ext cx="104901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</a:t>
            </a: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00bp</a:t>
            </a:r>
            <a:r>
              <a:rPr kumimoji="0" lang="en-US" altLang="ja-JP" sz="16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" name="テキスト ボックス 74">
            <a:extLst>
              <a:ext uri="{FF2B5EF4-FFF2-40B4-BE49-F238E27FC236}">
                <a16:creationId xmlns:a16="http://schemas.microsoft.com/office/drawing/2014/main" id="{3D8A5CFE-7F2B-6E4C-97FA-4EADA816F31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29460" y="2996912"/>
            <a:ext cx="104901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</a:t>
            </a:r>
            <a:r>
              <a:rPr kumimoji="0" lang="ja-JP" altLang="ja-JP" sz="1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00bp</a:t>
            </a:r>
            <a:r>
              <a:rPr kumimoji="0" lang="en-US" altLang="ja-JP" sz="16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endParaRPr kumimoji="0" lang="ja-JP" altLang="ja-JP" sz="16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" name="テキスト ボックス 68">
            <a:extLst>
              <a:ext uri="{FF2B5EF4-FFF2-40B4-BE49-F238E27FC236}">
                <a16:creationId xmlns:a16="http://schemas.microsoft.com/office/drawing/2014/main" id="{2EB9CBF5-912E-5549-91BD-1B6F66486895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8113796" y="3817422"/>
            <a:ext cx="1183030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ctum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63">
            <a:extLst>
              <a:ext uri="{FF2B5EF4-FFF2-40B4-BE49-F238E27FC236}">
                <a16:creationId xmlns:a16="http://schemas.microsoft.com/office/drawing/2014/main" id="{1F431270-EBB7-0C4A-B759-0F0DB1202D25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7344022" y="3900948"/>
            <a:ext cx="96168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leum</a:t>
            </a: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63">
            <a:extLst>
              <a:ext uri="{FF2B5EF4-FFF2-40B4-BE49-F238E27FC236}">
                <a16:creationId xmlns:a16="http://schemas.microsoft.com/office/drawing/2014/main" id="{0A391E11-CFD5-4445-9439-EB7692DB5899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6868969" y="3822025"/>
            <a:ext cx="117083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jejunum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2A40445F-B096-344C-A6EC-A0F4FA210F55}"/>
              </a:ext>
            </a:extLst>
          </p:cNvPr>
          <p:cNvSpPr/>
          <p:nvPr/>
        </p:nvSpPr>
        <p:spPr>
          <a:xfrm rot="18787375">
            <a:off x="6474598" y="3767603"/>
            <a:ext cx="13115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uodenum</a:t>
            </a: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68">
            <a:extLst>
              <a:ext uri="{FF2B5EF4-FFF2-40B4-BE49-F238E27FC236}">
                <a16:creationId xmlns:a16="http://schemas.microsoft.com/office/drawing/2014/main" id="{D9DF00C7-81D0-5D46-A8D9-AEFE7B0DBAEE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5685961" y="3848706"/>
            <a:ext cx="110012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4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ja-JP" altLang="ja-JP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uterus</a:t>
            </a:r>
            <a:endParaRPr kumimoji="0" lang="ja-JP" altLang="ja-JP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68">
            <a:extLst>
              <a:ext uri="{FF2B5EF4-FFF2-40B4-BE49-F238E27FC236}">
                <a16:creationId xmlns:a16="http://schemas.microsoft.com/office/drawing/2014/main" id="{DDC7E4C4-F34C-8B49-ADB5-62BE2A72D68E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5352620" y="3877926"/>
            <a:ext cx="102269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kidney</a:t>
            </a:r>
            <a:endParaRPr kumimoji="0" lang="ja-JP" altLang="ja-JP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68">
            <a:extLst>
              <a:ext uri="{FF2B5EF4-FFF2-40B4-BE49-F238E27FC236}">
                <a16:creationId xmlns:a16="http://schemas.microsoft.com/office/drawing/2014/main" id="{DC24250D-8DCC-2D4B-955A-316F2F59D6A7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4898347" y="3877926"/>
            <a:ext cx="102269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drenal</a:t>
            </a:r>
            <a:endParaRPr kumimoji="0" lang="ja-JP" altLang="ja-JP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68">
            <a:extLst>
              <a:ext uri="{FF2B5EF4-FFF2-40B4-BE49-F238E27FC236}">
                <a16:creationId xmlns:a16="http://schemas.microsoft.com/office/drawing/2014/main" id="{82C2EBA3-EBF3-E944-A32A-DDC581A7F8C2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4464637" y="3877926"/>
            <a:ext cx="102269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pleen</a:t>
            </a:r>
            <a:endParaRPr kumimoji="0" lang="ja-JP" altLang="ja-JP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68">
            <a:extLst>
              <a:ext uri="{FF2B5EF4-FFF2-40B4-BE49-F238E27FC236}">
                <a16:creationId xmlns:a16="http://schemas.microsoft.com/office/drawing/2014/main" id="{9479FDC4-F4EF-B947-9422-80072E8F920A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4092654" y="3892216"/>
            <a:ext cx="98482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ladder</a:t>
            </a:r>
            <a:endParaRPr kumimoji="0" lang="ja-JP" altLang="ja-JP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68">
            <a:extLst>
              <a:ext uri="{FF2B5EF4-FFF2-40B4-BE49-F238E27FC236}">
                <a16:creationId xmlns:a16="http://schemas.microsoft.com/office/drawing/2014/main" id="{08C30EF1-AFEE-F043-9431-ED2D42988C1B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3690521" y="3877926"/>
            <a:ext cx="102269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kumimoji="0" lang="ja-JP" altLang="ja-JP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8D5AD0AE-3FB6-D045-AB99-89139FDF877B}"/>
              </a:ext>
            </a:extLst>
          </p:cNvPr>
          <p:cNvSpPr/>
          <p:nvPr/>
        </p:nvSpPr>
        <p:spPr>
          <a:xfrm rot="18811578">
            <a:off x="4615520" y="1353922"/>
            <a:ext cx="15568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ippocampus</a:t>
            </a:r>
            <a:endParaRPr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66">
            <a:extLst>
              <a:ext uri="{FF2B5EF4-FFF2-40B4-BE49-F238E27FC236}">
                <a16:creationId xmlns:a16="http://schemas.microsoft.com/office/drawing/2014/main" id="{E65AA620-DAA9-BF43-AF9F-1B3204405334}"/>
              </a:ext>
            </a:extLst>
          </p:cNvPr>
          <p:cNvSpPr txBox="1">
            <a:spLocks noChangeArrowheads="1"/>
          </p:cNvSpPr>
          <p:nvPr/>
        </p:nvSpPr>
        <p:spPr bwMode="auto">
          <a:xfrm rot="-2940000">
            <a:off x="8629543" y="1400259"/>
            <a:ext cx="1355006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ja-JP" altLang="ja-JP">
                <a:solidFill>
                  <a:srgbClr val="000000"/>
                </a:solidFill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pancreas</a:t>
            </a:r>
            <a:endParaRPr kumimoji="0" lang="ja-JP" altLang="ja-JP">
              <a:latin typeface="Arial" panose="020B060402020202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endParaRPr kumimoji="0" lang="ja-JP" altLang="ja-JP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B2C0CEB8-7BA0-D24D-A7D1-539A0DF45E76}"/>
              </a:ext>
            </a:extLst>
          </p:cNvPr>
          <p:cNvSpPr/>
          <p:nvPr/>
        </p:nvSpPr>
        <p:spPr>
          <a:xfrm>
            <a:off x="3288292" y="1754442"/>
            <a:ext cx="377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0" lang="ja-JP" altLang="ja-JP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F95AE0B7-2BA8-E548-84E0-3DB6D0D3321A}"/>
              </a:ext>
            </a:extLst>
          </p:cNvPr>
          <p:cNvSpPr/>
          <p:nvPr/>
        </p:nvSpPr>
        <p:spPr>
          <a:xfrm>
            <a:off x="3340845" y="4094254"/>
            <a:ext cx="37702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0" lang="ja-JP" altLang="ja-JP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1658082-1CB8-7F47-BBA3-CAEAEF385E23}"/>
              </a:ext>
            </a:extLst>
          </p:cNvPr>
          <p:cNvSpPr txBox="1"/>
          <p:nvPr/>
        </p:nvSpPr>
        <p:spPr>
          <a:xfrm>
            <a:off x="5716979" y="6368143"/>
            <a:ext cx="9733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 S2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64">
            <a:extLst>
              <a:ext uri="{FF2B5EF4-FFF2-40B4-BE49-F238E27FC236}">
                <a16:creationId xmlns:a16="http://schemas.microsoft.com/office/drawing/2014/main" id="{ACAE8934-72BA-A84F-8EA7-82AF7C488A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65516" y="2248495"/>
            <a:ext cx="26084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SORSC1</a:t>
            </a:r>
            <a:r>
              <a:rPr lang="ja-JP" altLang="en-US" i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DNA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64">
            <a:extLst>
              <a:ext uri="{FF2B5EF4-FFF2-40B4-BE49-F238E27FC236}">
                <a16:creationId xmlns:a16="http://schemas.microsoft.com/office/drawing/2014/main" id="{43A945C7-87AE-4645-8723-3A65C9593B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65515" y="3006873"/>
            <a:ext cx="26084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DNA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三角形 45">
            <a:extLst>
              <a:ext uri="{FF2B5EF4-FFF2-40B4-BE49-F238E27FC236}">
                <a16:creationId xmlns:a16="http://schemas.microsoft.com/office/drawing/2014/main" id="{E5A72760-DEF8-6E43-B525-B3340301F8D0}"/>
              </a:ext>
            </a:extLst>
          </p:cNvPr>
          <p:cNvSpPr/>
          <p:nvPr/>
        </p:nvSpPr>
        <p:spPr>
          <a:xfrm rot="16200000">
            <a:off x="9191162" y="2362126"/>
            <a:ext cx="233239" cy="132418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三角形 47">
            <a:extLst>
              <a:ext uri="{FF2B5EF4-FFF2-40B4-BE49-F238E27FC236}">
                <a16:creationId xmlns:a16="http://schemas.microsoft.com/office/drawing/2014/main" id="{8A4B8DBD-0F67-FC4F-9861-3975E6EAAA55}"/>
              </a:ext>
            </a:extLst>
          </p:cNvPr>
          <p:cNvSpPr/>
          <p:nvPr/>
        </p:nvSpPr>
        <p:spPr>
          <a:xfrm rot="16200000">
            <a:off x="9191092" y="3110666"/>
            <a:ext cx="233239" cy="132418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テキスト ボックス 64">
            <a:extLst>
              <a:ext uri="{FF2B5EF4-FFF2-40B4-BE49-F238E27FC236}">
                <a16:creationId xmlns:a16="http://schemas.microsoft.com/office/drawing/2014/main" id="{196D395C-B4C3-F345-BFEA-5BE508C3DF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65515" y="4655817"/>
            <a:ext cx="26084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SORSC1</a:t>
            </a:r>
            <a:r>
              <a:rPr lang="ja-JP" altLang="en-US" i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DNA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64">
            <a:extLst>
              <a:ext uri="{FF2B5EF4-FFF2-40B4-BE49-F238E27FC236}">
                <a16:creationId xmlns:a16="http://schemas.microsoft.com/office/drawing/2014/main" id="{E7B76FC3-965E-994B-A675-5496DF7BFE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365514" y="5414195"/>
            <a:ext cx="260847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DNA</a:t>
            </a:r>
            <a:endParaRPr kumimoji="0" lang="ja-JP" altLang="ja-JP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三角形 51">
            <a:extLst>
              <a:ext uri="{FF2B5EF4-FFF2-40B4-BE49-F238E27FC236}">
                <a16:creationId xmlns:a16="http://schemas.microsoft.com/office/drawing/2014/main" id="{D0506120-866E-DD44-9C70-1E7D9D5093DF}"/>
              </a:ext>
            </a:extLst>
          </p:cNvPr>
          <p:cNvSpPr/>
          <p:nvPr/>
        </p:nvSpPr>
        <p:spPr>
          <a:xfrm rot="16200000">
            <a:off x="9191161" y="4769448"/>
            <a:ext cx="233239" cy="132418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三角形 52">
            <a:extLst>
              <a:ext uri="{FF2B5EF4-FFF2-40B4-BE49-F238E27FC236}">
                <a16:creationId xmlns:a16="http://schemas.microsoft.com/office/drawing/2014/main" id="{9B8F217B-23FD-4648-900F-11392923A511}"/>
              </a:ext>
            </a:extLst>
          </p:cNvPr>
          <p:cNvSpPr/>
          <p:nvPr/>
        </p:nvSpPr>
        <p:spPr>
          <a:xfrm rot="16200000">
            <a:off x="9191091" y="5517988"/>
            <a:ext cx="233239" cy="132418"/>
          </a:xfrm>
          <a:prstGeom prst="triangle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25529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72</TotalTime>
  <Words>63</Words>
  <Application>Microsoft Macintosh PowerPoint</Application>
  <PresentationFormat>ワイド画面</PresentationFormat>
  <Paragraphs>3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近江俊徳</dc:creator>
  <cp:lastModifiedBy>俊徳 近江</cp:lastModifiedBy>
  <cp:revision>97</cp:revision>
  <cp:lastPrinted>2026-01-06T03:51:56Z</cp:lastPrinted>
  <dcterms:created xsi:type="dcterms:W3CDTF">2019-09-27T07:41:50Z</dcterms:created>
  <dcterms:modified xsi:type="dcterms:W3CDTF">2026-01-24T13:13:10Z</dcterms:modified>
</cp:coreProperties>
</file>